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54838" cy="93091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A8416-F5A1-4B60-9E76-EC6E03B36B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763AF-68AD-4872-83C8-B8034AC200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C95AB-6596-4A7C-8609-E3564E43EE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C5931-9FF3-4011-8D75-4D710112BF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BE91B-8283-43CC-ABDD-19B54EAF55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8E1DD-80DD-4DA2-A0C9-A4A345B050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8F854-3CF8-4C9F-927B-B16DA6F498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6E5DE-59CD-4003-8FF3-8FC1B403BE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D77A5-53C4-4F2A-8688-8E8ED8158F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451D8-FC63-4710-AD70-7384369ADB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E6FDD-B2DB-4FF2-8383-2D4F3092E6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5D376-1A78-499F-8099-12B52960E1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83CCDB-C43F-4B8F-859E-10B87121419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Up Arrow 11"/>
          <p:cNvSpPr/>
          <p:nvPr/>
        </p:nvSpPr>
        <p:spPr>
          <a:xfrm>
            <a:off x="3870360" y="1978200"/>
            <a:ext cx="46080" cy="207720"/>
          </a:xfrm>
          <a:prstGeom prst="upArrow">
            <a:avLst>
              <a:gd name="adj1" fmla="val 50000"/>
              <a:gd name="adj2" fmla="val 49899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l 26"/>
          <p:cNvSpPr/>
          <p:nvPr/>
        </p:nvSpPr>
        <p:spPr>
          <a:xfrm>
            <a:off x="4219560" y="2567160"/>
            <a:ext cx="1600200" cy="696600"/>
          </a:xfrm>
          <a:prstGeom prst="ellipse">
            <a:avLst/>
          </a:prstGeom>
          <a:gradFill rotWithShape="0">
            <a:gsLst>
              <a:gs pos="0">
                <a:srgbClr val="bcbcbc"/>
              </a:gs>
              <a:gs pos="100000">
                <a:srgbClr val="ededed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Arial"/>
              </a:rPr>
              <a:t>Mitochondrial membrane depolariz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val 27"/>
          <p:cNvSpPr/>
          <p:nvPr/>
        </p:nvSpPr>
        <p:spPr>
          <a:xfrm>
            <a:off x="2212920" y="2673360"/>
            <a:ext cx="1216080" cy="482760"/>
          </a:xfrm>
          <a:prstGeom prst="ellipse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yclin D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28"/>
          <p:cNvSpPr/>
          <p:nvPr/>
        </p:nvSpPr>
        <p:spPr>
          <a:xfrm>
            <a:off x="3048120" y="2914560"/>
            <a:ext cx="938160" cy="403200"/>
          </a:xfrm>
          <a:prstGeom prst="ellipse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K-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Minus 29"/>
          <p:cNvSpPr/>
          <p:nvPr/>
        </p:nvSpPr>
        <p:spPr>
          <a:xfrm>
            <a:off x="2908440" y="2503440"/>
            <a:ext cx="276120" cy="41400"/>
          </a:xfrm>
          <a:custGeom>
            <a:avLst/>
            <a:gdLst>
              <a:gd name="textAreaLeft" fmla="*/ 36360 w 276120"/>
              <a:gd name="textAreaRight" fmla="*/ 239760 w 276120"/>
              <a:gd name="textAreaTop" fmla="*/ 15840 h 41400"/>
              <a:gd name="textAreaBottom" fmla="*/ 25560 h 41400"/>
            </a:gdLst>
            <a:ahLst/>
            <a:rect l="textAreaLeft" t="textAreaTop" r="textAreaRight" b="textAreaBottom"/>
            <a:pathLst>
              <a:path w="276225" h="41275">
                <a:moveTo>
                  <a:pt x="36614" y="15784"/>
                </a:moveTo>
                <a:lnTo>
                  <a:pt x="239611" y="15784"/>
                </a:lnTo>
                <a:lnTo>
                  <a:pt x="239611" y="25491"/>
                </a:lnTo>
                <a:lnTo>
                  <a:pt x="36614" y="25491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Minus 30"/>
          <p:cNvSpPr/>
          <p:nvPr/>
        </p:nvSpPr>
        <p:spPr>
          <a:xfrm rot="16200000">
            <a:off x="2918880" y="2408760"/>
            <a:ext cx="247320" cy="36360"/>
          </a:xfrm>
          <a:custGeom>
            <a:avLst/>
            <a:gdLst>
              <a:gd name="textAreaLeft" fmla="*/ 32760 w 247320"/>
              <a:gd name="textAreaRight" fmla="*/ 214560 w 247320"/>
              <a:gd name="textAreaTop" fmla="*/ 14040 h 36360"/>
              <a:gd name="textAreaBottom" fmla="*/ 22320 h 36360"/>
            </a:gdLst>
            <a:ahLst/>
            <a:rect l="textAreaLeft" t="textAreaTop" r="textAreaRight" b="textAreaBottom"/>
            <a:pathLst>
              <a:path w="247650" h="36512">
                <a:moveTo>
                  <a:pt x="32826" y="13962"/>
                </a:moveTo>
                <a:lnTo>
                  <a:pt x="214824" y="13962"/>
                </a:lnTo>
                <a:lnTo>
                  <a:pt x="214824" y="22550"/>
                </a:lnTo>
                <a:lnTo>
                  <a:pt x="32826" y="2255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Up Arrow 31"/>
          <p:cNvSpPr/>
          <p:nvPr/>
        </p:nvSpPr>
        <p:spPr>
          <a:xfrm flipH="1">
            <a:off x="2286000" y="2008080"/>
            <a:ext cx="46080" cy="206640"/>
          </a:xfrm>
          <a:prstGeom prst="upArrow">
            <a:avLst>
              <a:gd name="adj1" fmla="val 50000"/>
              <a:gd name="adj2" fmla="val 50013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Up Arrow 32"/>
          <p:cNvSpPr/>
          <p:nvPr/>
        </p:nvSpPr>
        <p:spPr>
          <a:xfrm flipH="1">
            <a:off x="5449320" y="2033640"/>
            <a:ext cx="36360" cy="162000"/>
          </a:xfrm>
          <a:prstGeom prst="upArrow">
            <a:avLst>
              <a:gd name="adj1" fmla="val 50000"/>
              <a:gd name="adj2" fmla="val 50227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Straight Arrow Connector 14"/>
          <p:cNvCxnSpPr/>
          <p:nvPr/>
        </p:nvCxnSpPr>
        <p:spPr>
          <a:xfrm flipH="1">
            <a:off x="3733560" y="1652400"/>
            <a:ext cx="37224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Straight Arrow Connector 36"/>
          <p:cNvCxnSpPr/>
          <p:nvPr/>
        </p:nvCxnSpPr>
        <p:spPr>
          <a:xfrm>
            <a:off x="4343040" y="1652400"/>
            <a:ext cx="30564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1" name="Up Arrow 45"/>
          <p:cNvSpPr/>
          <p:nvPr/>
        </p:nvSpPr>
        <p:spPr>
          <a:xfrm flipV="1">
            <a:off x="4025880" y="3024360"/>
            <a:ext cx="46080" cy="201600"/>
          </a:xfrm>
          <a:prstGeom prst="upArrow">
            <a:avLst>
              <a:gd name="adj1" fmla="val 50000"/>
              <a:gd name="adj2" fmla="val 49948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Up Arrow 46"/>
          <p:cNvSpPr/>
          <p:nvPr/>
        </p:nvSpPr>
        <p:spPr>
          <a:xfrm flipV="1">
            <a:off x="2097000" y="2795760"/>
            <a:ext cx="46080" cy="201600"/>
          </a:xfrm>
          <a:prstGeom prst="upArrow">
            <a:avLst>
              <a:gd name="adj1" fmla="val 50000"/>
              <a:gd name="adj2" fmla="val 49948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3" name="Straight Arrow Connector 47"/>
          <p:cNvCxnSpPr/>
          <p:nvPr/>
        </p:nvCxnSpPr>
        <p:spPr>
          <a:xfrm>
            <a:off x="4952520" y="2298240"/>
            <a:ext cx="108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4" name="Straight Arrow Connector 49"/>
          <p:cNvCxnSpPr/>
          <p:nvPr/>
        </p:nvCxnSpPr>
        <p:spPr>
          <a:xfrm flipH="1">
            <a:off x="5004720" y="3341520"/>
            <a:ext cx="5400" cy="293040"/>
          </a:xfrm>
          <a:prstGeom prst="straightConnector1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</p:cxnSp>
      <p:sp>
        <p:nvSpPr>
          <p:cNvPr id="55" name="Explosion 1 38"/>
          <p:cNvSpPr/>
          <p:nvPr/>
        </p:nvSpPr>
        <p:spPr>
          <a:xfrm>
            <a:off x="4343400" y="3633840"/>
            <a:ext cx="1523880" cy="914400"/>
          </a:xfrm>
          <a:prstGeom prst="irregularSeal1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ounded Rectangle 40"/>
          <p:cNvSpPr/>
          <p:nvPr/>
        </p:nvSpPr>
        <p:spPr>
          <a:xfrm>
            <a:off x="2286000" y="3862440"/>
            <a:ext cx="1371600" cy="3222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Arial"/>
              </a:rPr>
              <a:t>G0/G1 Arre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7" name="Straight Arrow Connector 56"/>
          <p:cNvCxnSpPr/>
          <p:nvPr/>
        </p:nvCxnSpPr>
        <p:spPr>
          <a:xfrm>
            <a:off x="3007800" y="3270240"/>
            <a:ext cx="1080" cy="381600"/>
          </a:xfrm>
          <a:prstGeom prst="straightConnector1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</p:cxnSp>
      <p:sp>
        <p:nvSpPr>
          <p:cNvPr id="58" name="TextBox 50"/>
          <p:cNvSpPr/>
          <p:nvPr/>
        </p:nvSpPr>
        <p:spPr>
          <a:xfrm>
            <a:off x="609480" y="4929120"/>
            <a:ext cx="569304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igure: Differential effects of 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sitosterol on h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uman cancer cell lines. 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sitosterol up-regulates CDKIs, p21 and p27 and down-regulates cyclin D1 and CDK4 to induce G1 arrest in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reast adenocarcinoma MDA- MB-231 cell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. On the other hand, it causes an increase in Bax/Bcl-2 ratio and mitochondrial membrane depolarization to induce apoptosis in breast cancer cells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"/>
          <p:cNvSpPr/>
          <p:nvPr/>
        </p:nvSpPr>
        <p:spPr>
          <a:xfrm>
            <a:off x="2666880" y="477720"/>
            <a:ext cx="130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sitoste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3"/>
          <p:cNvSpPr/>
          <p:nvPr/>
        </p:nvSpPr>
        <p:spPr>
          <a:xfrm>
            <a:off x="1527120" y="1042920"/>
            <a:ext cx="979200" cy="276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n canc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4"/>
          <p:cNvSpPr/>
          <p:nvPr/>
        </p:nvSpPr>
        <p:spPr>
          <a:xfrm>
            <a:off x="2592720" y="1042920"/>
            <a:ext cx="1023480" cy="276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ung canc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5"/>
          <p:cNvSpPr/>
          <p:nvPr/>
        </p:nvSpPr>
        <p:spPr>
          <a:xfrm>
            <a:off x="3737880" y="1042920"/>
            <a:ext cx="1123920" cy="2764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reast canc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ight Arrow 39"/>
          <p:cNvSpPr/>
          <p:nvPr/>
        </p:nvSpPr>
        <p:spPr>
          <a:xfrm>
            <a:off x="762120" y="1320840"/>
            <a:ext cx="761760" cy="304920"/>
          </a:xfrm>
          <a:prstGeom prst="rightArrow">
            <a:avLst>
              <a:gd name="adj1" fmla="val 50000"/>
              <a:gd name="adj2" fmla="val 49964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Efficac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41"/>
          <p:cNvSpPr/>
          <p:nvPr/>
        </p:nvSpPr>
        <p:spPr>
          <a:xfrm>
            <a:off x="1553760" y="1284120"/>
            <a:ext cx="298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                  +                   ++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44"/>
          <p:cNvSpPr/>
          <p:nvPr/>
        </p:nvSpPr>
        <p:spPr>
          <a:xfrm>
            <a:off x="4538880" y="1957320"/>
            <a:ext cx="834480" cy="27648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x/Bcl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51"/>
          <p:cNvSpPr/>
          <p:nvPr/>
        </p:nvSpPr>
        <p:spPr>
          <a:xfrm>
            <a:off x="2441520" y="1957320"/>
            <a:ext cx="1329840" cy="27648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KI: p21 &amp; p2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7" name="Straight Arrow Connector 55"/>
          <p:cNvCxnSpPr/>
          <p:nvPr/>
        </p:nvCxnSpPr>
        <p:spPr>
          <a:xfrm flipH="1">
            <a:off x="2361600" y="738000"/>
            <a:ext cx="53388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8" name="Straight Arrow Connector 57"/>
          <p:cNvCxnSpPr/>
          <p:nvPr/>
        </p:nvCxnSpPr>
        <p:spPr>
          <a:xfrm>
            <a:off x="3581280" y="738000"/>
            <a:ext cx="45792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9" name="Straight Arrow Connector 58"/>
          <p:cNvCxnSpPr/>
          <p:nvPr/>
        </p:nvCxnSpPr>
        <p:spPr>
          <a:xfrm flipH="1">
            <a:off x="3199680" y="777600"/>
            <a:ext cx="1080" cy="229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5T08:28:25Z</dcterms:created>
  <dc:creator>john9</dc:creator>
  <dc:description/>
  <dc:language>en-US</dc:language>
  <cp:lastModifiedBy>Rana P. Singh</cp:lastModifiedBy>
  <cp:lastPrinted>2012-11-27T09:54:44Z</cp:lastPrinted>
  <dcterms:modified xsi:type="dcterms:W3CDTF">2013-05-16T20:24:52Z</dcterms:modified>
  <cp:revision>561</cp:revision>
  <dc:subject/>
  <dc:title>EFFECT OF β-SITOSTEROL ON A-431 Cell line</dc:title>
</cp:coreProperties>
</file>